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44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297F6E-4077-4018-95C2-097C551BF6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2B1547-69A9-4D1E-A51C-50F23D291A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A39444-349B-46DD-B503-54BFC83A1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E9EAC-E0B4-411D-AF8E-A7CC0D5D8F05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BE43B3-9319-4349-A9E1-0DDB54F5E1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6A8023-73BD-4B0B-9C82-0C6432EF1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A4C24-B8DD-4F80-8ED1-E9DAD5925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1807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828865-9F5D-4878-B8EA-3558F338E7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ABC933C-DA48-44AC-A7BE-BAA9C7D9CF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8DDCB4-44C3-4C35-A5C5-F46E8CB358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E9EAC-E0B4-411D-AF8E-A7CC0D5D8F05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51F115-310F-4D06-8C3D-431A01AEB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F58B43-B26D-45A3-AE1D-B99BCF20AD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A4C24-B8DD-4F80-8ED1-E9DAD5925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677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9E08765-09F9-4C4A-89D1-B6D222923D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394877-DFD7-47B2-A190-3B604B797F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E7E0B9-AC1F-4522-A9BC-E5F5FDCC06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E9EAC-E0B4-411D-AF8E-A7CC0D5D8F05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45AF75-324F-45E3-BF14-95F4D9B84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C8414A-0B0F-4511-BFC0-11208BDC8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A4C24-B8DD-4F80-8ED1-E9DAD5925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505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A55C39-F851-46D1-93C6-02A022771C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7A5167-8E6C-404C-B7B5-5EB3A14FBF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CC3338-82E0-405E-9212-114E4A9BDC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E9EAC-E0B4-411D-AF8E-A7CC0D5D8F05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42925E-121B-4BDC-B9A8-7F530FE83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C4895C-0810-486E-93DE-C798FE12E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A4C24-B8DD-4F80-8ED1-E9DAD5925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805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D6CF03-A860-43C4-8D94-EC2C30BC1C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74AAE3-57B1-43EE-9EA4-C05E1DFFBD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6C301F-EFA4-4B6D-A0CA-1A2716DAD7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E9EAC-E0B4-411D-AF8E-A7CC0D5D8F05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F7E6E8-56A2-4CD2-8C9A-FDE21202C8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7E5074-CE90-4FA2-9633-D04394B46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A4C24-B8DD-4F80-8ED1-E9DAD5925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586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11962E-55A9-4277-80B1-424DA1C90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E7E6F3-4887-4EB3-BAC6-F5E5EA9AB9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3AB929-CF09-4F0A-BC8D-2432023612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BC766E-A64A-4397-AB87-A03401955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E9EAC-E0B4-411D-AF8E-A7CC0D5D8F05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BB9433-9A2F-422D-8A54-9AC1A96BC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E8A238-71B2-4C90-8490-34D811755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A4C24-B8DD-4F80-8ED1-E9DAD5925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207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0B3F9-8D2A-4F51-87B1-FDC42A60D6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A0A175-F18B-43CE-9E1C-49E5B8E95B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A296BD-3EF6-4835-94F6-6703A84820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24E1FC5-4AE2-4C45-A8D6-2D9B2E48BC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2DB7A3F-93EC-4B41-A34F-89153D8455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3279FE-FC43-4790-91B0-849D6228A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E9EAC-E0B4-411D-AF8E-A7CC0D5D8F05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AC568B-1676-4D51-9FB3-C39254ED7B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1FEE94C-544C-4C64-B281-31F8D3532B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A4C24-B8DD-4F80-8ED1-E9DAD5925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925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45143F-6E4C-4B2E-AD4D-7A4BCA0337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712D49D-08A5-4ACA-930D-EE617E1A0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E9EAC-E0B4-411D-AF8E-A7CC0D5D8F05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A00A93-FD67-4231-AF09-A5CEC82DE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772EAF2-4E03-4499-8D43-482AAB0563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A4C24-B8DD-4F80-8ED1-E9DAD5925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278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9A204F-BA93-4D31-8F40-0783751A1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E9EAC-E0B4-411D-AF8E-A7CC0D5D8F05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FDCC945-E118-4213-ACE9-DD96493F1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8D4FBDD-EAD9-419F-80FD-BAA4CD316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A4C24-B8DD-4F80-8ED1-E9DAD5925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038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433CEA-5207-45DE-83FB-8400A6016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8D942E-254F-4AC5-BE32-442D649F31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E2D05A-FCE3-4BDF-B1B2-46A65EB849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1B4AD3-23F4-4BCF-8847-7960F0433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E9EAC-E0B4-411D-AF8E-A7CC0D5D8F05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A774E7-4BF8-4AB7-B7A4-6D2430272B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DDD5F8-6D44-459F-B8AB-32638FF05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A4C24-B8DD-4F80-8ED1-E9DAD5925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552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7A8792-C0BB-4CA7-B077-EBFF047BA9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B64C56-56C1-4A1D-B2F8-992F807BA4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8F3A72-83E3-4FF1-A767-FFCFA440D0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FC1EA2-4391-436E-8DEA-3000EA785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E9EAC-E0B4-411D-AF8E-A7CC0D5D8F05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7889B4-57FA-44DA-B24B-071407FAE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46E3D2-7AF4-4399-B2F1-1D6B3263A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0A4C24-B8DD-4F80-8ED1-E9DAD5925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71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602911-49CD-4B97-A133-F963CD1E2A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2682BE-A79C-4A31-B8A2-B42B1E35DD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88E896-08E1-4E69-89AD-FB80D9C6E0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E9EAC-E0B4-411D-AF8E-A7CC0D5D8F05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B3618D-32AB-4524-A4A3-91CAB5ACB9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91ECE6-C4AD-477B-8732-A661CA537D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0A4C24-B8DD-4F80-8ED1-E9DAD5925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686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5E3249B-9D92-4CBF-A030-52AFE672FCEE}"/>
              </a:ext>
            </a:extLst>
          </p:cNvPr>
          <p:cNvSpPr txBox="1"/>
          <p:nvPr/>
        </p:nvSpPr>
        <p:spPr>
          <a:xfrm>
            <a:off x="1612170" y="581297"/>
            <a:ext cx="86576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. Forward and reverse primers used to amplify and validate the mitochondrion-to-</a:t>
            </a:r>
            <a:r>
              <a:rPr lang="en-US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stidial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NA transfer in </a:t>
            </a:r>
            <a:r>
              <a:rPr lang="en-US" sz="1200" b="1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loxylon</a:t>
            </a:r>
            <a:r>
              <a:rPr lang="en-US" sz="12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mmodendron</a:t>
            </a:r>
            <a:r>
              <a:rPr lang="en-US" sz="12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. </a:t>
            </a:r>
            <a:r>
              <a:rPr lang="en-US" sz="1200" b="1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sicum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751B1285-E5A0-4AA8-94CE-A47545288E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9844753"/>
              </p:ext>
            </p:extLst>
          </p:nvPr>
        </p:nvGraphicFramePr>
        <p:xfrm>
          <a:off x="1612170" y="1340231"/>
          <a:ext cx="8657685" cy="399462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64963">
                  <a:extLst>
                    <a:ext uri="{9D8B030D-6E8A-4147-A177-3AD203B41FA5}">
                      <a16:colId xmlns:a16="http://schemas.microsoft.com/office/drawing/2014/main" val="2380666128"/>
                    </a:ext>
                  </a:extLst>
                </a:gridCol>
                <a:gridCol w="925017">
                  <a:extLst>
                    <a:ext uri="{9D8B030D-6E8A-4147-A177-3AD203B41FA5}">
                      <a16:colId xmlns:a16="http://schemas.microsoft.com/office/drawing/2014/main" val="3625123704"/>
                    </a:ext>
                  </a:extLst>
                </a:gridCol>
                <a:gridCol w="947578">
                  <a:extLst>
                    <a:ext uri="{9D8B030D-6E8A-4147-A177-3AD203B41FA5}">
                      <a16:colId xmlns:a16="http://schemas.microsoft.com/office/drawing/2014/main" val="2047661543"/>
                    </a:ext>
                  </a:extLst>
                </a:gridCol>
                <a:gridCol w="2576692">
                  <a:extLst>
                    <a:ext uri="{9D8B030D-6E8A-4147-A177-3AD203B41FA5}">
                      <a16:colId xmlns:a16="http://schemas.microsoft.com/office/drawing/2014/main" val="1124236799"/>
                    </a:ext>
                  </a:extLst>
                </a:gridCol>
                <a:gridCol w="749808">
                  <a:extLst>
                    <a:ext uri="{9D8B030D-6E8A-4147-A177-3AD203B41FA5}">
                      <a16:colId xmlns:a16="http://schemas.microsoft.com/office/drawing/2014/main" val="1078887403"/>
                    </a:ext>
                  </a:extLst>
                </a:gridCol>
                <a:gridCol w="2093627">
                  <a:extLst>
                    <a:ext uri="{9D8B030D-6E8A-4147-A177-3AD203B41FA5}">
                      <a16:colId xmlns:a16="http://schemas.microsoft.com/office/drawing/2014/main" val="2065414206"/>
                    </a:ext>
                  </a:extLst>
                </a:gridCol>
              </a:tblGrid>
              <a:tr h="3625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section</a:t>
                      </a:r>
                      <a:endParaRPr lang="en-US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85000"/>
                        <a:lumOff val="1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Name</a:t>
                      </a:r>
                      <a:endParaRPr lang="en-US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85000"/>
                        <a:lumOff val="1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rectionality</a:t>
                      </a:r>
                      <a:endParaRPr lang="en-US" sz="1200" b="1" i="0" u="none" strike="noStrike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85000"/>
                        <a:lumOff val="1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  <a:endParaRPr lang="en-US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85000"/>
                        <a:lumOff val="1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con Size</a:t>
                      </a:r>
                      <a:endParaRPr lang="en-US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85000"/>
                        <a:lumOff val="1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on of the 5' end base in the chloroplast genome</a:t>
                      </a:r>
                      <a:endParaRPr lang="en-US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85000"/>
                        <a:lumOff val="1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1229903"/>
                  </a:ext>
                </a:extLst>
              </a:tr>
              <a:tr h="3625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cf1-ndhf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6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TCAACGTCAAATGATTT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0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216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6677815"/>
                  </a:ext>
                </a:extLst>
              </a:tr>
              <a:tr h="3625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7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CCCGTTTATTCATCCTTAA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7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4548236"/>
                  </a:ext>
                </a:extLst>
              </a:tr>
              <a:tr h="3625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cf1-ndhf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7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TGTTTTATCATCGAAATTTGT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6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9224718"/>
                  </a:ext>
                </a:extLst>
              </a:tr>
              <a:tr h="3625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CCCGTTTATTCATCCTTAA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7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5627980"/>
                  </a:ext>
                </a:extLst>
              </a:tr>
              <a:tr h="3625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cf1-ndhf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7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TGTTTTATCATCGAAATTTGT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6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1064402"/>
                  </a:ext>
                </a:extLst>
              </a:tr>
              <a:tr h="3625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ACCTTAGCTCTTGCT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97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8293862"/>
                  </a:ext>
                </a:extLst>
              </a:tr>
              <a:tr h="3625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 extra region-ndhF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GAATCACCCTTTGTTA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59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6356842"/>
                  </a:ext>
                </a:extLst>
              </a:tr>
              <a:tr h="3625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ACCTTAGCTCTTGCT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97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7116543"/>
                  </a:ext>
                </a:extLst>
              </a:tr>
              <a:tr h="36251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cf1-4.8 extra regio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7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TGTTTTATCATCGAAATTTGT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5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6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4031435"/>
                  </a:ext>
                </a:extLst>
              </a:tr>
              <a:tr h="3625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7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CCGATCAGGTGTTCT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06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707" marR="3707" marT="370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04460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383648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</Words>
  <Application>Microsoft Office PowerPoint</Application>
  <PresentationFormat>Widescreen</PresentationFormat>
  <Paragraphs>5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uce Williamson Benavides</dc:creator>
  <cp:lastModifiedBy>Amit Dhingra</cp:lastModifiedBy>
  <cp:revision>2</cp:revision>
  <dcterms:created xsi:type="dcterms:W3CDTF">2020-04-14T03:39:51Z</dcterms:created>
  <dcterms:modified xsi:type="dcterms:W3CDTF">2020-04-17T10:27:54Z</dcterms:modified>
</cp:coreProperties>
</file>